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0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3719" autoAdjust="0"/>
  </p:normalViewPr>
  <p:slideViewPr>
    <p:cSldViewPr>
      <p:cViewPr>
        <p:scale>
          <a:sx n="70" d="100"/>
          <a:sy n="70" d="100"/>
        </p:scale>
        <p:origin x="-1716" y="-29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D0C127A-65D9-4257-AB54-BFF2575DCB07}" type="datetimeFigureOut">
              <a:rPr lang="en-GB" smtClean="0"/>
              <a:pPr/>
              <a:t>05/09/2013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5BD48EF-94A9-49AB-8904-D956D12BAD47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6798994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ECA2C36-B6DE-4864-9339-FADEE753FB8F}" type="slidenum">
              <a:rPr lang="en-GB" smtClean="0"/>
              <a:pPr/>
              <a:t>1</a:t>
            </a:fld>
            <a:endParaRPr lang="en-GB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BB7C45-EAAB-475C-BF0F-6EA14F973924}" type="datetimeFigureOut">
              <a:rPr lang="en-GB" smtClean="0"/>
              <a:pPr/>
              <a:t>05/09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839594-290B-47B2-B9A8-20D0E84C13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BB7C45-EAAB-475C-BF0F-6EA14F973924}" type="datetimeFigureOut">
              <a:rPr lang="en-GB" smtClean="0"/>
              <a:pPr/>
              <a:t>05/09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839594-290B-47B2-B9A8-20D0E84C13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BB7C45-EAAB-475C-BF0F-6EA14F973924}" type="datetimeFigureOut">
              <a:rPr lang="en-GB" smtClean="0"/>
              <a:pPr/>
              <a:t>05/09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839594-290B-47B2-B9A8-20D0E84C13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BB7C45-EAAB-475C-BF0F-6EA14F973924}" type="datetimeFigureOut">
              <a:rPr lang="en-GB" smtClean="0"/>
              <a:pPr/>
              <a:t>05/09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839594-290B-47B2-B9A8-20D0E84C13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BB7C45-EAAB-475C-BF0F-6EA14F973924}" type="datetimeFigureOut">
              <a:rPr lang="en-GB" smtClean="0"/>
              <a:pPr/>
              <a:t>05/09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839594-290B-47B2-B9A8-20D0E84C13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BB7C45-EAAB-475C-BF0F-6EA14F973924}" type="datetimeFigureOut">
              <a:rPr lang="en-GB" smtClean="0"/>
              <a:pPr/>
              <a:t>05/09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839594-290B-47B2-B9A8-20D0E84C13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BB7C45-EAAB-475C-BF0F-6EA14F973924}" type="datetimeFigureOut">
              <a:rPr lang="en-GB" smtClean="0"/>
              <a:pPr/>
              <a:t>05/09/201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839594-290B-47B2-B9A8-20D0E84C13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BB7C45-EAAB-475C-BF0F-6EA14F973924}" type="datetimeFigureOut">
              <a:rPr lang="en-GB" smtClean="0"/>
              <a:pPr/>
              <a:t>05/09/201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839594-290B-47B2-B9A8-20D0E84C13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BB7C45-EAAB-475C-BF0F-6EA14F973924}" type="datetimeFigureOut">
              <a:rPr lang="en-GB" smtClean="0"/>
              <a:pPr/>
              <a:t>05/09/201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839594-290B-47B2-B9A8-20D0E84C13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BB7C45-EAAB-475C-BF0F-6EA14F973924}" type="datetimeFigureOut">
              <a:rPr lang="en-GB" smtClean="0"/>
              <a:pPr/>
              <a:t>05/09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839594-290B-47B2-B9A8-20D0E84C13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BB7C45-EAAB-475C-BF0F-6EA14F973924}" type="datetimeFigureOut">
              <a:rPr lang="en-GB" smtClean="0"/>
              <a:pPr/>
              <a:t>05/09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839594-290B-47B2-B9A8-20D0E84C13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BB7C45-EAAB-475C-BF0F-6EA14F973924}" type="datetimeFigureOut">
              <a:rPr lang="en-GB" smtClean="0"/>
              <a:pPr/>
              <a:t>05/09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839594-290B-47B2-B9A8-20D0E84C1394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5" Type="http://schemas.openxmlformats.org/officeDocument/2006/relationships/image" Target="../media/image1.emf"/><Relationship Id="rId4" Type="http://schemas.openxmlformats.org/officeDocument/2006/relationships/oleObject" Target="../embeddings/oleObject1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0966" name="Objec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1022304"/>
              </p:ext>
            </p:extLst>
          </p:nvPr>
        </p:nvGraphicFramePr>
        <p:xfrm>
          <a:off x="261938" y="922338"/>
          <a:ext cx="6262687" cy="23542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84" name="Prism 5" r:id="rId4" imgW="6547320" imgH="2459880" progId="Prism5.Document">
                  <p:embed/>
                </p:oleObj>
              </mc:Choice>
              <mc:Fallback>
                <p:oleObj name="Prism 5" r:id="rId4" imgW="6547320" imgH="2459880" progId="Prism5.Document">
                  <p:embed/>
                  <p:pic>
                    <p:nvPicPr>
                      <p:cNvPr id="0" name="Picture 9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5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61938" y="922338"/>
                        <a:ext cx="6262687" cy="235426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2" name="Group 4"/>
          <p:cNvGrpSpPr/>
          <p:nvPr/>
        </p:nvGrpSpPr>
        <p:grpSpPr>
          <a:xfrm>
            <a:off x="188640" y="941403"/>
            <a:ext cx="3560168" cy="246221"/>
            <a:chOff x="244760" y="971600"/>
            <a:chExt cx="3560168" cy="246221"/>
          </a:xfrm>
        </p:grpSpPr>
        <p:sp>
          <p:nvSpPr>
            <p:cNvPr id="6" name="TextBox 5"/>
            <p:cNvSpPr txBox="1"/>
            <p:nvPr/>
          </p:nvSpPr>
          <p:spPr>
            <a:xfrm>
              <a:off x="244760" y="971600"/>
              <a:ext cx="37592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 smtClean="0"/>
                <a:t>(A)</a:t>
              </a:r>
              <a:endParaRPr lang="en-GB" sz="1000" b="1" dirty="0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3429000" y="971600"/>
              <a:ext cx="37592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 smtClean="0"/>
                <a:t>(B)</a:t>
              </a:r>
              <a:endParaRPr lang="en-GB" sz="1000" b="1" dirty="0"/>
            </a:p>
          </p:txBody>
        </p:sp>
      </p:grpSp>
      <p:sp>
        <p:nvSpPr>
          <p:cNvPr id="8" name="Rectangle 3"/>
          <p:cNvSpPr>
            <a:spLocks noChangeAspect="1" noChangeArrowheads="1"/>
          </p:cNvSpPr>
          <p:nvPr/>
        </p:nvSpPr>
        <p:spPr bwMode="auto">
          <a:xfrm>
            <a:off x="0" y="386244"/>
            <a:ext cx="622800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1" fontAlgn="base" latinLnBrk="0" hangingPunct="1"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Calibri" pitchFamily="34" charset="0"/>
                <a:cs typeface="Times New Roman" pitchFamily="18" charset="0"/>
              </a:rPr>
              <a:t>Additional File 6</a:t>
            </a:r>
            <a:endParaRPr kumimoji="0" lang="en-GB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082" name="Rectangle 10"/>
          <p:cNvSpPr>
            <a:spLocks noChangeArrowheads="1"/>
          </p:cNvSpPr>
          <p:nvPr/>
        </p:nvSpPr>
        <p:spPr bwMode="auto">
          <a:xfrm>
            <a:off x="0" y="3400417"/>
            <a:ext cx="6858000" cy="83099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Times New Roman" pitchFamily="18" charset="0"/>
                <a:cs typeface="Times New Roman" pitchFamily="18" charset="0"/>
              </a:rPr>
              <a:t>The expression of CXCL10 mRNA in LPS stimulated alveolar macrophages.  </a:t>
            </a:r>
            <a:endParaRPr kumimoji="0" lang="en-GB" sz="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Times New Roman" pitchFamily="18" charset="0"/>
                <a:cs typeface="Times New Roman" pitchFamily="18" charset="0"/>
              </a:rPr>
              <a:t>Macrophages from smoking controls (n=8) (A) and COPD patients (n=8) (B) were stimulated with LPS (1 µg/ml) for 6 or 24 h prior to RNA extraction and PCR analysis for CXCL10.  Data shown are median ± range.  * = significant difference compared to time matched control (p&lt;0.05).</a:t>
            </a:r>
            <a:endParaRPr kumimoji="0" lang="en-GB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10</TotalTime>
  <Words>82</Words>
  <Application>Microsoft Office PowerPoint</Application>
  <PresentationFormat>On-screen Show (4:3)</PresentationFormat>
  <Paragraphs>6</Paragraphs>
  <Slides>1</Slides>
  <Notes>1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3" baseType="lpstr">
      <vt:lpstr>Office Theme</vt:lpstr>
      <vt:lpstr>GraphPad Prism 5 Project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Simon Lea</dc:creator>
  <cp:lastModifiedBy>Andrew Higham</cp:lastModifiedBy>
  <cp:revision>46</cp:revision>
  <dcterms:created xsi:type="dcterms:W3CDTF">2012-05-28T12:09:01Z</dcterms:created>
  <dcterms:modified xsi:type="dcterms:W3CDTF">2013-09-05T11:19:50Z</dcterms:modified>
</cp:coreProperties>
</file>